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18AB9FB-A3BF-4351-A56E-16851DE506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087AEFC-94F1-4A51-9C19-C3760DEFBD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D364513-489E-4E5D-A5B1-7B0E5ADEE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FA5460-76AB-4ACB-A933-73DB1EC8B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02D96E-2E4F-4130-852D-141100BFB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691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9BE564-612D-4F00-B956-358C772BB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F4A9E5-5C33-4DFE-BF86-F1B6BFBD9C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D2602C-E5D7-4621-99F7-2FA3AD402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82D47E-BE8A-4400-99F0-B08243988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D67C6A-383A-46BA-92DB-EEBF344BC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005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1E5994D-4D86-4B2A-9E6D-0EDE25CAAB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754DFB-E776-430E-A8AE-9AB3190C2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8F1E31-5842-49EA-BF43-5F50426A7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D8915D-9A4F-4852-A6CE-5D62E2067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93E0AB-6D32-4912-8CB9-D5679B1F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26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3C5B5F-04CD-4A31-BF93-EDBA3C03C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4AFE711-A456-47BD-811A-811D11AB30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C31404-7662-425E-81B1-B25B998B5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866F4D-53E3-4F2B-81DA-3139E4715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63A995-47D4-4C97-B9F4-24636F33F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605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C3BABF-3BAA-4B33-A9B5-848A6C18F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BF2DEED-0D03-44A0-AC38-9CD2F1285D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8060CA-2D0B-4BB6-8FE6-20D83E199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7F1A841-EE5C-468D-BAA0-692D7E35B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FBE6EB-B969-4BBA-A70C-64DAEDC48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471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81170D-3F38-41D3-BDE1-34C784976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0FC2D10-F0B9-42D6-A401-5EC16D8F13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7A8A471-CA1F-4B8B-B376-6DC1003536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C62880-5BCF-47D9-9AFA-6155E23A3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B7102B-9046-4DE8-99A3-5BF6536BC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2CC358-9A27-480B-A13D-9970B72D0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671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4030C1-76A0-4D90-B702-F2BFF55109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765CC0-C2A1-477F-84DE-5C2B2FF8D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5578798-2F6F-4BB0-ABB4-3D43D7B1DA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8A169F-62FC-40FF-8BDF-149B0DF442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5C200EA-DF3C-4EC6-A928-B2AD73862C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4ACA2BC-8D47-4CDC-889B-B0D32E97F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B77FB6A-EEC8-4436-8BE3-589C073DC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32E256F-526E-43C5-A334-1EC9F07C1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923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10201C-295B-4D9F-8DAF-BC6160590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2333DD1-D3DA-49DF-8DEA-421DD7C9E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10CC7EB-1B3D-4F0D-B9FD-46580610B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EE2C47C-27DE-4491-A7D8-00A53175D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014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52CD53C-B473-4FF3-A36F-311590A8A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D5FED18-7D88-4FB7-AA54-68F85B8B6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3BCCF65-AA58-4954-95FE-A4ADFECF8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7497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34C130-0E15-4BC4-A819-BD0933E32C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D0FC64-EBD5-45B8-BEA5-B891769FE0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B8DDFD-5502-4D70-9E68-2E9761A15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8D53EC4-B9F0-4FD7-B34F-CF9EE647E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3760CF-89CB-47B8-8935-1D457855B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63B2B8-7A70-4C8A-AF3E-D0477DD86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0902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98346C-310A-44ED-A03F-D36523545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6D41416-CCA7-46EA-BC5F-2710F60613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2B4EB9F-E307-4892-ABAB-A7199764BA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89CDEA8-6D49-42FC-949E-34BA8DC03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3CDFB9-F369-4E93-BE77-8FF754ECA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EC1A7E-52DA-4167-BF95-1D1ED6018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18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AA6929B-79F2-4026-9AD9-11B15F80C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BDA2932-5098-4329-961B-E31EE3AA6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B5AAF7-FE56-43DA-9DA3-746EFDEF77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12D2C-B94B-4BED-BD36-36567DAEFB13}" type="datetimeFigureOut">
              <a:rPr kumimoji="1" lang="ja-JP" altLang="en-US" smtClean="0"/>
              <a:t>2023/9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9BA16D-90BA-422F-8DF4-BE1DBE3752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7E3BEA-392E-4DE2-A3E8-7B09096ABB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C4BA0-86C9-45F4-B982-027706AAF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821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Line 8">
            <a:extLst>
              <a:ext uri="{FF2B5EF4-FFF2-40B4-BE49-F238E27FC236}">
                <a16:creationId xmlns:a16="http://schemas.microsoft.com/office/drawing/2014/main" id="{17374450-56E4-4867-8610-E3252A9E4B2E}"/>
              </a:ext>
            </a:extLst>
          </p:cNvPr>
          <p:cNvSpPr>
            <a:spLocks noChangeShapeType="1"/>
          </p:cNvSpPr>
          <p:nvPr/>
        </p:nvSpPr>
        <p:spPr bwMode="auto">
          <a:xfrm>
            <a:off x="3647096" y="4108606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Line 9">
            <a:extLst>
              <a:ext uri="{FF2B5EF4-FFF2-40B4-BE49-F238E27FC236}">
                <a16:creationId xmlns:a16="http://schemas.microsoft.com/office/drawing/2014/main" id="{E7891CC0-86E7-4802-A025-C1683BA8629F}"/>
              </a:ext>
            </a:extLst>
          </p:cNvPr>
          <p:cNvSpPr>
            <a:spLocks noChangeShapeType="1"/>
          </p:cNvSpPr>
          <p:nvPr/>
        </p:nvSpPr>
        <p:spPr bwMode="auto">
          <a:xfrm>
            <a:off x="3647096" y="3491068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10">
            <a:extLst>
              <a:ext uri="{FF2B5EF4-FFF2-40B4-BE49-F238E27FC236}">
                <a16:creationId xmlns:a16="http://schemas.microsoft.com/office/drawing/2014/main" id="{A8C42026-0991-4637-99E0-71EC04A0BF5E}"/>
              </a:ext>
            </a:extLst>
          </p:cNvPr>
          <p:cNvSpPr>
            <a:spLocks noChangeShapeType="1"/>
          </p:cNvSpPr>
          <p:nvPr/>
        </p:nvSpPr>
        <p:spPr bwMode="auto">
          <a:xfrm>
            <a:off x="3647096" y="2873531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Line 11">
            <a:extLst>
              <a:ext uri="{FF2B5EF4-FFF2-40B4-BE49-F238E27FC236}">
                <a16:creationId xmlns:a16="http://schemas.microsoft.com/office/drawing/2014/main" id="{96FD84B6-ABE3-47F7-BD4F-A31CB7100130}"/>
              </a:ext>
            </a:extLst>
          </p:cNvPr>
          <p:cNvSpPr>
            <a:spLocks noChangeShapeType="1"/>
          </p:cNvSpPr>
          <p:nvPr/>
        </p:nvSpPr>
        <p:spPr bwMode="auto">
          <a:xfrm>
            <a:off x="3647096" y="2254406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12">
            <a:extLst>
              <a:ext uri="{FF2B5EF4-FFF2-40B4-BE49-F238E27FC236}">
                <a16:creationId xmlns:a16="http://schemas.microsoft.com/office/drawing/2014/main" id="{7A29715F-B994-4131-A575-450DEFE81DAC}"/>
              </a:ext>
            </a:extLst>
          </p:cNvPr>
          <p:cNvSpPr>
            <a:spLocks noChangeShapeType="1"/>
          </p:cNvSpPr>
          <p:nvPr/>
        </p:nvSpPr>
        <p:spPr bwMode="auto">
          <a:xfrm>
            <a:off x="3647096" y="1636868"/>
            <a:ext cx="396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Line 13">
            <a:extLst>
              <a:ext uri="{FF2B5EF4-FFF2-40B4-BE49-F238E27FC236}">
                <a16:creationId xmlns:a16="http://schemas.microsoft.com/office/drawing/2014/main" id="{E06B5732-96FB-426E-8F5F-413FE7A51BD5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4418168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14">
            <a:extLst>
              <a:ext uri="{FF2B5EF4-FFF2-40B4-BE49-F238E27FC236}">
                <a16:creationId xmlns:a16="http://schemas.microsoft.com/office/drawing/2014/main" id="{C10792EA-45B7-4C62-8B84-31ACCE92EA4E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3800631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Line 15">
            <a:extLst>
              <a:ext uri="{FF2B5EF4-FFF2-40B4-BE49-F238E27FC236}">
                <a16:creationId xmlns:a16="http://schemas.microsoft.com/office/drawing/2014/main" id="{1461D8AF-38D6-4266-BAF7-5131A7630C2B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3181506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16">
            <a:extLst>
              <a:ext uri="{FF2B5EF4-FFF2-40B4-BE49-F238E27FC236}">
                <a16:creationId xmlns:a16="http://schemas.microsoft.com/office/drawing/2014/main" id="{15C18E25-40AE-4087-BFC5-050D34D4841E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2563968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17">
            <a:extLst>
              <a:ext uri="{FF2B5EF4-FFF2-40B4-BE49-F238E27FC236}">
                <a16:creationId xmlns:a16="http://schemas.microsoft.com/office/drawing/2014/main" id="{F850E09E-AEA5-4C4E-8951-14783696A83B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1946431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18">
            <a:extLst>
              <a:ext uri="{FF2B5EF4-FFF2-40B4-BE49-F238E27FC236}">
                <a16:creationId xmlns:a16="http://schemas.microsoft.com/office/drawing/2014/main" id="{2219AA3F-15DF-4A31-8401-D6A0935D3D68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8996" y="1327306"/>
            <a:ext cx="77788" cy="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9">
            <a:extLst>
              <a:ext uri="{FF2B5EF4-FFF2-40B4-BE49-F238E27FC236}">
                <a16:creationId xmlns:a16="http://schemas.microsoft.com/office/drawing/2014/main" id="{F50B2005-24F3-444A-8DF9-A7E3AAA9EB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421" y="4316568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20">
            <a:extLst>
              <a:ext uri="{FF2B5EF4-FFF2-40B4-BE49-F238E27FC236}">
                <a16:creationId xmlns:a16="http://schemas.microsoft.com/office/drawing/2014/main" id="{8887EA29-3512-4880-A68E-6A4977FCD4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5933" y="3684743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21">
            <a:extLst>
              <a:ext uri="{FF2B5EF4-FFF2-40B4-BE49-F238E27FC236}">
                <a16:creationId xmlns:a16="http://schemas.microsoft.com/office/drawing/2014/main" id="{927FAC30-2EB3-4060-A5D1-B93F14738C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5933" y="3067206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4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22">
            <a:extLst>
              <a:ext uri="{FF2B5EF4-FFF2-40B4-BE49-F238E27FC236}">
                <a16:creationId xmlns:a16="http://schemas.microsoft.com/office/drawing/2014/main" id="{AD97C9EF-8AAB-4F57-A722-9E814BD7EB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5933" y="2448081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6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23">
            <a:extLst>
              <a:ext uri="{FF2B5EF4-FFF2-40B4-BE49-F238E27FC236}">
                <a16:creationId xmlns:a16="http://schemas.microsoft.com/office/drawing/2014/main" id="{569F335A-788B-493A-A432-C3FB5BBE30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5933" y="1830543"/>
            <a:ext cx="30777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8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24">
            <a:extLst>
              <a:ext uri="{FF2B5EF4-FFF2-40B4-BE49-F238E27FC236}">
                <a16:creationId xmlns:a16="http://schemas.microsoft.com/office/drawing/2014/main" id="{4B27C108-CA59-4DBA-B8F0-FCE20A97FD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45446" y="1213006"/>
            <a:ext cx="3847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%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26">
            <a:extLst>
              <a:ext uri="{FF2B5EF4-FFF2-40B4-BE49-F238E27FC236}">
                <a16:creationId xmlns:a16="http://schemas.microsoft.com/office/drawing/2014/main" id="{C4CCB326-9556-4532-92C8-F141982B17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78846" y="1320956"/>
            <a:ext cx="4579938" cy="309086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Rectangle 29">
            <a:extLst>
              <a:ext uri="{FF2B5EF4-FFF2-40B4-BE49-F238E27FC236}">
                <a16:creationId xmlns:a16="http://schemas.microsoft.com/office/drawing/2014/main" id="{355E2282-C0FC-4E56-BA3E-B71D3B7CD8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86783" y="1327306"/>
            <a:ext cx="4578350" cy="3090863"/>
          </a:xfrm>
          <a:prstGeom prst="rect">
            <a:avLst/>
          </a:prstGeom>
          <a:noFill/>
          <a:ln w="12700" cap="sq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Line 31">
            <a:extLst>
              <a:ext uri="{FF2B5EF4-FFF2-40B4-BE49-F238E27FC236}">
                <a16:creationId xmlns:a16="http://schemas.microsoft.com/office/drawing/2014/main" id="{1D97DEBC-9867-4DE6-8073-B2E7C78E28E0}"/>
              </a:ext>
            </a:extLst>
          </p:cNvPr>
          <p:cNvSpPr>
            <a:spLocks noChangeShapeType="1"/>
          </p:cNvSpPr>
          <p:nvPr/>
        </p:nvSpPr>
        <p:spPr bwMode="auto">
          <a:xfrm>
            <a:off x="4201133" y="4418168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32">
            <a:extLst>
              <a:ext uri="{FF2B5EF4-FFF2-40B4-BE49-F238E27FC236}">
                <a16:creationId xmlns:a16="http://schemas.microsoft.com/office/drawing/2014/main" id="{5BE15A41-780A-4F40-B52D-EE6FD6C03A1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17133" y="4418168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33">
            <a:extLst>
              <a:ext uri="{FF2B5EF4-FFF2-40B4-BE49-F238E27FC236}">
                <a16:creationId xmlns:a16="http://schemas.microsoft.com/office/drawing/2014/main" id="{B9905200-3250-427F-A2C7-6AA319D3A78C}"/>
              </a:ext>
            </a:extLst>
          </p:cNvPr>
          <p:cNvSpPr>
            <a:spLocks noChangeShapeType="1"/>
          </p:cNvSpPr>
          <p:nvPr/>
        </p:nvSpPr>
        <p:spPr bwMode="auto">
          <a:xfrm>
            <a:off x="6233133" y="4418168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34">
            <a:extLst>
              <a:ext uri="{FF2B5EF4-FFF2-40B4-BE49-F238E27FC236}">
                <a16:creationId xmlns:a16="http://schemas.microsoft.com/office/drawing/2014/main" id="{F8B82D54-0AEE-489F-9583-F2E449E815E6}"/>
              </a:ext>
            </a:extLst>
          </p:cNvPr>
          <p:cNvSpPr>
            <a:spLocks noChangeShapeType="1"/>
          </p:cNvSpPr>
          <p:nvPr/>
        </p:nvSpPr>
        <p:spPr bwMode="auto">
          <a:xfrm>
            <a:off x="7249133" y="4418168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Line 35">
            <a:extLst>
              <a:ext uri="{FF2B5EF4-FFF2-40B4-BE49-F238E27FC236}">
                <a16:creationId xmlns:a16="http://schemas.microsoft.com/office/drawing/2014/main" id="{D3935B7F-E3BD-4BAD-AC2B-872921DABFEB}"/>
              </a:ext>
            </a:extLst>
          </p:cNvPr>
          <p:cNvSpPr>
            <a:spLocks noChangeShapeType="1"/>
          </p:cNvSpPr>
          <p:nvPr/>
        </p:nvSpPr>
        <p:spPr bwMode="auto">
          <a:xfrm>
            <a:off x="8265133" y="4418168"/>
            <a:ext cx="0" cy="38100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36">
            <a:extLst>
              <a:ext uri="{FF2B5EF4-FFF2-40B4-BE49-F238E27FC236}">
                <a16:creationId xmlns:a16="http://schemas.microsoft.com/office/drawing/2014/main" id="{9208BB80-C2FA-45A1-833F-4F04F722AB49}"/>
              </a:ext>
            </a:extLst>
          </p:cNvPr>
          <p:cNvSpPr>
            <a:spLocks noChangeShapeType="1"/>
          </p:cNvSpPr>
          <p:nvPr/>
        </p:nvSpPr>
        <p:spPr bwMode="auto">
          <a:xfrm>
            <a:off x="3686783" y="4418168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Line 37">
            <a:extLst>
              <a:ext uri="{FF2B5EF4-FFF2-40B4-BE49-F238E27FC236}">
                <a16:creationId xmlns:a16="http://schemas.microsoft.com/office/drawing/2014/main" id="{1DB7EFE7-2872-4157-9F83-0A2BAEE797C0}"/>
              </a:ext>
            </a:extLst>
          </p:cNvPr>
          <p:cNvSpPr>
            <a:spLocks noChangeShapeType="1"/>
          </p:cNvSpPr>
          <p:nvPr/>
        </p:nvSpPr>
        <p:spPr bwMode="auto">
          <a:xfrm>
            <a:off x="4702783" y="4418168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38">
            <a:extLst>
              <a:ext uri="{FF2B5EF4-FFF2-40B4-BE49-F238E27FC236}">
                <a16:creationId xmlns:a16="http://schemas.microsoft.com/office/drawing/2014/main" id="{D2735E41-33E6-428B-9310-98DF4EF019DF}"/>
              </a:ext>
            </a:extLst>
          </p:cNvPr>
          <p:cNvSpPr>
            <a:spLocks noChangeShapeType="1"/>
          </p:cNvSpPr>
          <p:nvPr/>
        </p:nvSpPr>
        <p:spPr bwMode="auto">
          <a:xfrm>
            <a:off x="5718783" y="4418168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39">
            <a:extLst>
              <a:ext uri="{FF2B5EF4-FFF2-40B4-BE49-F238E27FC236}">
                <a16:creationId xmlns:a16="http://schemas.microsoft.com/office/drawing/2014/main" id="{C4F3DD72-061C-4D3C-92D3-EB706DB44F2F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4783" y="4418168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Line 40">
            <a:extLst>
              <a:ext uri="{FF2B5EF4-FFF2-40B4-BE49-F238E27FC236}">
                <a16:creationId xmlns:a16="http://schemas.microsoft.com/office/drawing/2014/main" id="{6EF0E2F9-9A26-41B7-8E7F-306CC3EDD41D}"/>
              </a:ext>
            </a:extLst>
          </p:cNvPr>
          <p:cNvSpPr>
            <a:spLocks noChangeShapeType="1"/>
          </p:cNvSpPr>
          <p:nvPr/>
        </p:nvSpPr>
        <p:spPr bwMode="auto">
          <a:xfrm>
            <a:off x="7750783" y="4418168"/>
            <a:ext cx="0" cy="77788"/>
          </a:xfrm>
          <a:prstGeom prst="line">
            <a:avLst/>
          </a:prstGeom>
          <a:noFill/>
          <a:ln w="12700" cap="flat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41">
            <a:extLst>
              <a:ext uri="{FF2B5EF4-FFF2-40B4-BE49-F238E27FC236}">
                <a16:creationId xmlns:a16="http://schemas.microsoft.com/office/drawing/2014/main" id="{10885880-37CF-4E81-8957-CA5CA53DB1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34396" y="4495956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0</a:t>
            </a:r>
            <a:endParaRPr kumimoji="0" lang="ja-JP" altLang="ja-JP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tangle 42">
            <a:extLst>
              <a:ext uri="{FF2B5EF4-FFF2-40B4-BE49-F238E27FC236}">
                <a16:creationId xmlns:a16="http://schemas.microsoft.com/office/drawing/2014/main" id="{2B77E72E-33BB-45E7-B3AA-1ACD48A55F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12296" y="4495956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5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43">
            <a:extLst>
              <a:ext uri="{FF2B5EF4-FFF2-40B4-BE49-F238E27FC236}">
                <a16:creationId xmlns:a16="http://schemas.microsoft.com/office/drawing/2014/main" id="{E3CFA89E-06B1-428C-AA5D-E0C109D937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77496" y="4495956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0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44">
            <a:extLst>
              <a:ext uri="{FF2B5EF4-FFF2-40B4-BE49-F238E27FC236}">
                <a16:creationId xmlns:a16="http://schemas.microsoft.com/office/drawing/2014/main" id="{574DD166-1DBB-4D62-94C9-D436822AE4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93496" y="4495956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15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45">
            <a:extLst>
              <a:ext uri="{FF2B5EF4-FFF2-40B4-BE49-F238E27FC236}">
                <a16:creationId xmlns:a16="http://schemas.microsoft.com/office/drawing/2014/main" id="{B19DF3BE-2AED-40F4-BDC6-2EA908B005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09496" y="4495956"/>
            <a:ext cx="23083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00</a:t>
            </a:r>
            <a:endParaRPr kumimoji="0" lang="ja-JP" altLang="ja-JP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99">
            <a:extLst>
              <a:ext uri="{FF2B5EF4-FFF2-40B4-BE49-F238E27FC236}">
                <a16:creationId xmlns:a16="http://schemas.microsoft.com/office/drawing/2014/main" id="{27155B06-F484-488D-9F82-D320B547B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1428" y="1484766"/>
            <a:ext cx="1221809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61</a:t>
            </a:r>
            <a:endParaRPr kumimoji="1" lang="en-US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1EB82FDC-4187-4390-9BC7-8929967CF1B9}"/>
              </a:ext>
            </a:extLst>
          </p:cNvPr>
          <p:cNvGrpSpPr/>
          <p:nvPr/>
        </p:nvGrpSpPr>
        <p:grpSpPr>
          <a:xfrm>
            <a:off x="8469339" y="1452901"/>
            <a:ext cx="2893155" cy="525394"/>
            <a:chOff x="7204076" y="995392"/>
            <a:chExt cx="2893155" cy="525394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B3C2BF2A-9990-4DD7-9B3F-9D7267A30025}"/>
                </a:ext>
              </a:extLst>
            </p:cNvPr>
            <p:cNvCxnSpPr>
              <a:cxnSpLocks/>
            </p:cNvCxnSpPr>
            <p:nvPr/>
          </p:nvCxnSpPr>
          <p:spPr>
            <a:xfrm>
              <a:off x="7204076" y="1133891"/>
              <a:ext cx="490537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6D251952-068C-47B3-8FFF-0FA441F3DAA1}"/>
                </a:ext>
              </a:extLst>
            </p:cNvPr>
            <p:cNvCxnSpPr>
              <a:cxnSpLocks/>
            </p:cNvCxnSpPr>
            <p:nvPr/>
          </p:nvCxnSpPr>
          <p:spPr>
            <a:xfrm>
              <a:off x="7204076" y="1382286"/>
              <a:ext cx="490537" cy="0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14D0EA29-9636-427E-9045-DF69112CB1AE}"/>
                </a:ext>
              </a:extLst>
            </p:cNvPr>
            <p:cNvSpPr txBox="1"/>
            <p:nvPr/>
          </p:nvSpPr>
          <p:spPr>
            <a:xfrm>
              <a:off x="7754923" y="1243787"/>
              <a:ext cx="2342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LC intermediate-stage (n=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7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FD17F31F-B923-4627-B252-BACDE7A29040}"/>
                </a:ext>
              </a:extLst>
            </p:cNvPr>
            <p:cNvSpPr txBox="1"/>
            <p:nvPr/>
          </p:nvSpPr>
          <p:spPr>
            <a:xfrm>
              <a:off x="7751203" y="995392"/>
              <a:ext cx="1837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L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early-stage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=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4B4B1BB-98B1-4CB9-863D-F9E8B5B0088F}"/>
              </a:ext>
            </a:extLst>
          </p:cNvPr>
          <p:cNvSpPr txBox="1"/>
          <p:nvPr/>
        </p:nvSpPr>
        <p:spPr>
          <a:xfrm rot="10800000">
            <a:off x="2609890" y="2218777"/>
            <a:ext cx="369332" cy="1361911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 rate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BC312A9-1F7E-40D8-B0FF-FB76EF815236}"/>
              </a:ext>
            </a:extLst>
          </p:cNvPr>
          <p:cNvSpPr txBox="1"/>
          <p:nvPr/>
        </p:nvSpPr>
        <p:spPr>
          <a:xfrm>
            <a:off x="5822490" y="4672667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s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A336BA7-17FD-4C73-9313-5E7F4AABFBCA}"/>
              </a:ext>
            </a:extLst>
          </p:cNvPr>
          <p:cNvSpPr txBox="1"/>
          <p:nvPr/>
        </p:nvSpPr>
        <p:spPr>
          <a:xfrm>
            <a:off x="1535035" y="327976"/>
            <a:ext cx="93961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fference in overall survival rates based on the BCLC staging system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8" name="表 47">
            <a:extLst>
              <a:ext uri="{FF2B5EF4-FFF2-40B4-BE49-F238E27FC236}">
                <a16:creationId xmlns:a16="http://schemas.microsoft.com/office/drawing/2014/main" id="{4B047F6A-D8C8-42BA-8D51-8BC9105ED8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2743751"/>
              </p:ext>
            </p:extLst>
          </p:nvPr>
        </p:nvGraphicFramePr>
        <p:xfrm>
          <a:off x="3686782" y="5059708"/>
          <a:ext cx="4570413" cy="5314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29727">
                  <a:extLst>
                    <a:ext uri="{9D8B030D-6E8A-4147-A177-3AD203B41FA5}">
                      <a16:colId xmlns:a16="http://schemas.microsoft.com/office/drawing/2014/main" val="454546147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2444571349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3758975132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3693967791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3352727057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1676416663"/>
                    </a:ext>
                  </a:extLst>
                </a:gridCol>
                <a:gridCol w="506781">
                  <a:extLst>
                    <a:ext uri="{9D8B030D-6E8A-4147-A177-3AD203B41FA5}">
                      <a16:colId xmlns:a16="http://schemas.microsoft.com/office/drawing/2014/main" val="622839648"/>
                    </a:ext>
                  </a:extLst>
                </a:gridCol>
              </a:tblGrid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altLang="ja-JP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156072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rly-stage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644946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mediate-stage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2287601"/>
                  </a:ext>
                </a:extLst>
              </a:tr>
            </a:tbl>
          </a:graphicData>
        </a:graphic>
      </p:graphicFrame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20EE6F9F-27E9-4729-9610-60C574B58DE7}"/>
              </a:ext>
            </a:extLst>
          </p:cNvPr>
          <p:cNvSpPr txBox="1"/>
          <p:nvPr/>
        </p:nvSpPr>
        <p:spPr>
          <a:xfrm>
            <a:off x="3701099" y="4781917"/>
            <a:ext cx="109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at risk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Freeform 27">
            <a:extLst>
              <a:ext uri="{FF2B5EF4-FFF2-40B4-BE49-F238E27FC236}">
                <a16:creationId xmlns:a16="http://schemas.microsoft.com/office/drawing/2014/main" id="{14CD20AB-65F3-7BF2-61EC-840A9C3583CE}"/>
              </a:ext>
            </a:extLst>
          </p:cNvPr>
          <p:cNvSpPr>
            <a:spLocks/>
          </p:cNvSpPr>
          <p:nvPr/>
        </p:nvSpPr>
        <p:spPr bwMode="auto">
          <a:xfrm>
            <a:off x="3666940" y="1338572"/>
            <a:ext cx="4421372" cy="2977995"/>
          </a:xfrm>
          <a:custGeom>
            <a:avLst/>
            <a:gdLst>
              <a:gd name="T0" fmla="*/ 66 w 2844"/>
              <a:gd name="T1" fmla="*/ 0 h 1939"/>
              <a:gd name="T2" fmla="*/ 105 w 2844"/>
              <a:gd name="T3" fmla="*/ 43 h 1939"/>
              <a:gd name="T4" fmla="*/ 171 w 2844"/>
              <a:gd name="T5" fmla="*/ 128 h 1939"/>
              <a:gd name="T6" fmla="*/ 223 w 2844"/>
              <a:gd name="T7" fmla="*/ 170 h 1939"/>
              <a:gd name="T8" fmla="*/ 263 w 2844"/>
              <a:gd name="T9" fmla="*/ 255 h 1939"/>
              <a:gd name="T10" fmla="*/ 289 w 2844"/>
              <a:gd name="T11" fmla="*/ 339 h 1939"/>
              <a:gd name="T12" fmla="*/ 302 w 2844"/>
              <a:gd name="T13" fmla="*/ 466 h 1939"/>
              <a:gd name="T14" fmla="*/ 354 w 2844"/>
              <a:gd name="T15" fmla="*/ 509 h 1939"/>
              <a:gd name="T16" fmla="*/ 367 w 2844"/>
              <a:gd name="T17" fmla="*/ 593 h 1939"/>
              <a:gd name="T18" fmla="*/ 420 w 2844"/>
              <a:gd name="T19" fmla="*/ 636 h 1939"/>
              <a:gd name="T20" fmla="*/ 446 w 2844"/>
              <a:gd name="T21" fmla="*/ 678 h 1939"/>
              <a:gd name="T22" fmla="*/ 512 w 2844"/>
              <a:gd name="T23" fmla="*/ 720 h 1939"/>
              <a:gd name="T24" fmla="*/ 525 w 2844"/>
              <a:gd name="T25" fmla="*/ 762 h 1939"/>
              <a:gd name="T26" fmla="*/ 538 w 2844"/>
              <a:gd name="T27" fmla="*/ 805 h 1939"/>
              <a:gd name="T28" fmla="*/ 564 w 2844"/>
              <a:gd name="T29" fmla="*/ 847 h 1939"/>
              <a:gd name="T30" fmla="*/ 577 w 2844"/>
              <a:gd name="T31" fmla="*/ 889 h 1939"/>
              <a:gd name="T32" fmla="*/ 590 w 2844"/>
              <a:gd name="T33" fmla="*/ 932 h 1939"/>
              <a:gd name="T34" fmla="*/ 630 w 2844"/>
              <a:gd name="T35" fmla="*/ 974 h 1939"/>
              <a:gd name="T36" fmla="*/ 669 w 2844"/>
              <a:gd name="T37" fmla="*/ 1016 h 1939"/>
              <a:gd name="T38" fmla="*/ 695 w 2844"/>
              <a:gd name="T39" fmla="*/ 1059 h 1939"/>
              <a:gd name="T40" fmla="*/ 708 w 2844"/>
              <a:gd name="T41" fmla="*/ 1101 h 1939"/>
              <a:gd name="T42" fmla="*/ 721 w 2844"/>
              <a:gd name="T43" fmla="*/ 1143 h 1939"/>
              <a:gd name="T44" fmla="*/ 787 w 2844"/>
              <a:gd name="T45" fmla="*/ 1186 h 1939"/>
              <a:gd name="T46" fmla="*/ 826 w 2844"/>
              <a:gd name="T47" fmla="*/ 1228 h 1939"/>
              <a:gd name="T48" fmla="*/ 839 w 2844"/>
              <a:gd name="T49" fmla="*/ 1271 h 1939"/>
              <a:gd name="T50" fmla="*/ 918 w 2844"/>
              <a:gd name="T51" fmla="*/ 1313 h 1939"/>
              <a:gd name="T52" fmla="*/ 931 w 2844"/>
              <a:gd name="T53" fmla="*/ 1355 h 1939"/>
              <a:gd name="T54" fmla="*/ 944 w 2844"/>
              <a:gd name="T55" fmla="*/ 1398 h 1939"/>
              <a:gd name="T56" fmla="*/ 957 w 2844"/>
              <a:gd name="T57" fmla="*/ 1482 h 1939"/>
              <a:gd name="T58" fmla="*/ 996 w 2844"/>
              <a:gd name="T59" fmla="*/ 1567 h 1939"/>
              <a:gd name="T60" fmla="*/ 1035 w 2844"/>
              <a:gd name="T61" fmla="*/ 1609 h 1939"/>
              <a:gd name="T62" fmla="*/ 1193 w 2844"/>
              <a:gd name="T63" fmla="*/ 1652 h 1939"/>
              <a:gd name="T64" fmla="*/ 1219 w 2844"/>
              <a:gd name="T65" fmla="*/ 1736 h 1939"/>
              <a:gd name="T66" fmla="*/ 1521 w 2844"/>
              <a:gd name="T67" fmla="*/ 1787 h 1939"/>
              <a:gd name="T68" fmla="*/ 1626 w 2844"/>
              <a:gd name="T69" fmla="*/ 1838 h 1939"/>
              <a:gd name="T70" fmla="*/ 1639 w 2844"/>
              <a:gd name="T71" fmla="*/ 1889 h 1939"/>
              <a:gd name="T72" fmla="*/ 1651 w 2844"/>
              <a:gd name="T73" fmla="*/ 1939 h 193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</a:cxnLst>
            <a:rect l="0" t="0" r="r" b="b"/>
            <a:pathLst>
              <a:path w="2844" h="1939">
                <a:moveTo>
                  <a:pt x="0" y="0"/>
                </a:moveTo>
                <a:lnTo>
                  <a:pt x="66" y="0"/>
                </a:lnTo>
                <a:lnTo>
                  <a:pt x="66" y="43"/>
                </a:lnTo>
                <a:lnTo>
                  <a:pt x="105" y="43"/>
                </a:lnTo>
                <a:lnTo>
                  <a:pt x="105" y="128"/>
                </a:lnTo>
                <a:lnTo>
                  <a:pt x="171" y="128"/>
                </a:lnTo>
                <a:lnTo>
                  <a:pt x="171" y="170"/>
                </a:lnTo>
                <a:lnTo>
                  <a:pt x="223" y="170"/>
                </a:lnTo>
                <a:lnTo>
                  <a:pt x="223" y="255"/>
                </a:lnTo>
                <a:lnTo>
                  <a:pt x="263" y="255"/>
                </a:lnTo>
                <a:lnTo>
                  <a:pt x="263" y="339"/>
                </a:lnTo>
                <a:lnTo>
                  <a:pt x="289" y="339"/>
                </a:lnTo>
                <a:lnTo>
                  <a:pt x="289" y="466"/>
                </a:lnTo>
                <a:lnTo>
                  <a:pt x="302" y="466"/>
                </a:lnTo>
                <a:lnTo>
                  <a:pt x="302" y="509"/>
                </a:lnTo>
                <a:lnTo>
                  <a:pt x="354" y="509"/>
                </a:lnTo>
                <a:lnTo>
                  <a:pt x="354" y="593"/>
                </a:lnTo>
                <a:lnTo>
                  <a:pt x="367" y="593"/>
                </a:lnTo>
                <a:lnTo>
                  <a:pt x="367" y="636"/>
                </a:lnTo>
                <a:lnTo>
                  <a:pt x="420" y="636"/>
                </a:lnTo>
                <a:lnTo>
                  <a:pt x="420" y="678"/>
                </a:lnTo>
                <a:lnTo>
                  <a:pt x="446" y="678"/>
                </a:lnTo>
                <a:lnTo>
                  <a:pt x="446" y="720"/>
                </a:lnTo>
                <a:lnTo>
                  <a:pt x="512" y="720"/>
                </a:lnTo>
                <a:lnTo>
                  <a:pt x="512" y="762"/>
                </a:lnTo>
                <a:lnTo>
                  <a:pt x="525" y="762"/>
                </a:lnTo>
                <a:lnTo>
                  <a:pt x="525" y="805"/>
                </a:lnTo>
                <a:lnTo>
                  <a:pt x="538" y="805"/>
                </a:lnTo>
                <a:lnTo>
                  <a:pt x="538" y="847"/>
                </a:lnTo>
                <a:lnTo>
                  <a:pt x="564" y="847"/>
                </a:lnTo>
                <a:lnTo>
                  <a:pt x="564" y="889"/>
                </a:lnTo>
                <a:lnTo>
                  <a:pt x="577" y="889"/>
                </a:lnTo>
                <a:lnTo>
                  <a:pt x="577" y="932"/>
                </a:lnTo>
                <a:lnTo>
                  <a:pt x="590" y="932"/>
                </a:lnTo>
                <a:lnTo>
                  <a:pt x="590" y="974"/>
                </a:lnTo>
                <a:lnTo>
                  <a:pt x="630" y="974"/>
                </a:lnTo>
                <a:lnTo>
                  <a:pt x="630" y="1016"/>
                </a:lnTo>
                <a:lnTo>
                  <a:pt x="669" y="1016"/>
                </a:lnTo>
                <a:lnTo>
                  <a:pt x="669" y="1059"/>
                </a:lnTo>
                <a:lnTo>
                  <a:pt x="695" y="1059"/>
                </a:lnTo>
                <a:lnTo>
                  <a:pt x="695" y="1101"/>
                </a:lnTo>
                <a:lnTo>
                  <a:pt x="708" y="1101"/>
                </a:lnTo>
                <a:lnTo>
                  <a:pt x="708" y="1143"/>
                </a:lnTo>
                <a:lnTo>
                  <a:pt x="721" y="1143"/>
                </a:lnTo>
                <a:lnTo>
                  <a:pt x="721" y="1186"/>
                </a:lnTo>
                <a:lnTo>
                  <a:pt x="787" y="1186"/>
                </a:lnTo>
                <a:lnTo>
                  <a:pt x="787" y="1228"/>
                </a:lnTo>
                <a:lnTo>
                  <a:pt x="826" y="1228"/>
                </a:lnTo>
                <a:lnTo>
                  <a:pt x="826" y="1271"/>
                </a:lnTo>
                <a:lnTo>
                  <a:pt x="839" y="1271"/>
                </a:lnTo>
                <a:lnTo>
                  <a:pt x="839" y="1313"/>
                </a:lnTo>
                <a:lnTo>
                  <a:pt x="918" y="1313"/>
                </a:lnTo>
                <a:lnTo>
                  <a:pt x="918" y="1355"/>
                </a:lnTo>
                <a:lnTo>
                  <a:pt x="931" y="1355"/>
                </a:lnTo>
                <a:lnTo>
                  <a:pt x="931" y="1398"/>
                </a:lnTo>
                <a:lnTo>
                  <a:pt x="944" y="1398"/>
                </a:lnTo>
                <a:lnTo>
                  <a:pt x="944" y="1482"/>
                </a:lnTo>
                <a:lnTo>
                  <a:pt x="957" y="1482"/>
                </a:lnTo>
                <a:lnTo>
                  <a:pt x="957" y="1567"/>
                </a:lnTo>
                <a:lnTo>
                  <a:pt x="996" y="1567"/>
                </a:lnTo>
                <a:lnTo>
                  <a:pt x="996" y="1609"/>
                </a:lnTo>
                <a:lnTo>
                  <a:pt x="1035" y="1609"/>
                </a:lnTo>
                <a:lnTo>
                  <a:pt x="1035" y="1652"/>
                </a:lnTo>
                <a:lnTo>
                  <a:pt x="1193" y="1652"/>
                </a:lnTo>
                <a:lnTo>
                  <a:pt x="1193" y="1736"/>
                </a:lnTo>
                <a:lnTo>
                  <a:pt x="1219" y="1736"/>
                </a:lnTo>
                <a:lnTo>
                  <a:pt x="1521" y="1736"/>
                </a:lnTo>
                <a:lnTo>
                  <a:pt x="1521" y="1787"/>
                </a:lnTo>
                <a:lnTo>
                  <a:pt x="1626" y="1787"/>
                </a:lnTo>
                <a:lnTo>
                  <a:pt x="1626" y="1838"/>
                </a:lnTo>
                <a:lnTo>
                  <a:pt x="1639" y="1838"/>
                </a:lnTo>
                <a:lnTo>
                  <a:pt x="1639" y="1889"/>
                </a:lnTo>
                <a:lnTo>
                  <a:pt x="1651" y="1889"/>
                </a:lnTo>
                <a:lnTo>
                  <a:pt x="1651" y="1939"/>
                </a:lnTo>
                <a:lnTo>
                  <a:pt x="2844" y="1939"/>
                </a:lnTo>
              </a:path>
            </a:pathLst>
          </a:custGeom>
          <a:noFill/>
          <a:ln w="26988" cap="flat">
            <a:solidFill>
              <a:srgbClr val="4270DD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id="{74342190-F225-8B32-63D9-6EEE2BD9D8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2868" y="1333655"/>
            <a:ext cx="4220711" cy="2590285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C2D7152-4B5B-7C34-8D45-BAFBE23CA7AE}"/>
              </a:ext>
            </a:extLst>
          </p:cNvPr>
          <p:cNvSpPr txBox="1"/>
          <p:nvPr/>
        </p:nvSpPr>
        <p:spPr>
          <a:xfrm>
            <a:off x="1658804" y="6040754"/>
            <a:ext cx="94478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C early-stage (n=53) vs. intermediate-stage (n=47) was not statistically significant based on the log-rank test (P=0.061).</a:t>
            </a:r>
          </a:p>
        </p:txBody>
      </p:sp>
    </p:spTree>
    <p:extLst>
      <p:ext uri="{BB962C8B-B14F-4D97-AF65-F5344CB8AC3E}">
        <p14:creationId xmlns:p14="http://schemas.microsoft.com/office/powerpoint/2010/main" val="3819785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3</TotalTime>
  <Words>100</Words>
  <Application>Microsoft Office PowerPoint</Application>
  <PresentationFormat>ワイド画面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naka Takashi</dc:creator>
  <cp:lastModifiedBy>Tanaka Takashi</cp:lastModifiedBy>
  <cp:revision>62</cp:revision>
  <cp:lastPrinted>2021-10-19T09:44:10Z</cp:lastPrinted>
  <dcterms:created xsi:type="dcterms:W3CDTF">2020-04-07T09:59:01Z</dcterms:created>
  <dcterms:modified xsi:type="dcterms:W3CDTF">2023-09-12T11:04:59Z</dcterms:modified>
</cp:coreProperties>
</file>